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7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150025-96EF-8D92-EDB9-572C52E0DEA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D263E62-E5B1-43DD-26E8-AA44CD463F9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A12D12-A124-26AF-0481-ACEA6081CE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F86DD-C6FE-1140-85C8-99C91FA611DD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AEFEC0-1A14-40A9-F9AE-8131C924B0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AFCC08-96A6-C2F7-4F25-5D0618F6C1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3BA0B-D3BC-4E4E-8CB5-4EBFE3CD1A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53198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13B1E8-21A3-0C82-C7D5-FE9AAC5D49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B2E205-44A4-EB17-035D-3DC95A99EB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07902F-CBA1-7CFB-5685-8C0547622E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F86DD-C6FE-1140-85C8-99C91FA611DD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10578C-7026-848A-421F-49FCB9FE5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81D43F-2709-97E6-A93C-5B69BD1BC9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3BA0B-D3BC-4E4E-8CB5-4EBFE3CD1A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49997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14D6EBD-DEDB-69FC-6C20-9396B795F7B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F457FD-2199-C85B-EF90-043FC2182A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0EA5A-94FD-6858-3270-F8DD1B1870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F86DD-C6FE-1140-85C8-99C91FA611DD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6CFD7A-55D6-8712-3FD9-03A8F03F39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2ED526-723D-576F-7358-A2792DD0FB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3BA0B-D3BC-4E4E-8CB5-4EBFE3CD1A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3158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C46116-9408-80C5-6D95-2A0B0B7F21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139158-DC6F-728C-4853-728574B0C3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1F804B-EA0A-52C9-E576-5612C93A7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F86DD-C6FE-1140-85C8-99C91FA611DD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14EA15-1733-A1EA-00C9-9F476C331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C3ED71-E9E9-D26A-D74E-1F9F54104F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3BA0B-D3BC-4E4E-8CB5-4EBFE3CD1A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99729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627F06-D0A0-5CA5-9F77-70B2FD4DEF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A2DC47-F70D-D1F7-8DA6-7024589CB3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BEF1AF-8F95-1FD2-6A19-3CAA69565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F86DD-C6FE-1140-85C8-99C91FA611DD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7C95A1-F1C0-DFC4-A8AA-C2DC92047A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C45944-D338-D56E-ED00-5B7B183DF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3BA0B-D3BC-4E4E-8CB5-4EBFE3CD1A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80841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976D34-0CD8-E583-2830-55D421BC91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A08816-8234-9A32-AFF5-3FAEAC99F0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E0DA11-11EC-65DF-BEB4-65EB66793C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31FF54-560A-3437-59D0-4C16696877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F86DD-C6FE-1140-85C8-99C91FA611DD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A09877-5C97-D42C-B62A-44EA571A3B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0BF2E0-A7F3-BA07-A637-B5680E711A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3BA0B-D3BC-4E4E-8CB5-4EBFE3CD1A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06898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F216B7-457E-32D0-3592-4FE073595C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87E372-261A-693A-DD52-B1F313088E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D904A3-F051-C291-BC19-489CC3C054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9001329-B54C-576C-AF54-E62DCD4696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98A71C0-79DE-4ECA-6F4D-3310A42D9E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19E037D-E1F6-CA28-D098-EEACD590C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F86DD-C6FE-1140-85C8-99C91FA611DD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659B31C-51B5-F6AB-FD2E-E9D8AB2EA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A129230-BF28-557E-6E8E-65E0EE8475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3BA0B-D3BC-4E4E-8CB5-4EBFE3CD1A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30299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EE54A3-BBBE-0211-C001-27E3625A68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390B5B6-521C-C677-B502-958D34161A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F86DD-C6FE-1140-85C8-99C91FA611DD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74F54D5-72C4-7C40-E4B7-4A9BC710F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AC1C5D0-B508-77D9-155A-9D7CB77C57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3BA0B-D3BC-4E4E-8CB5-4EBFE3CD1A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11554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F66E1C-8925-25BB-6A03-E535613A3F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F86DD-C6FE-1140-85C8-99C91FA611DD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D3F3697-2807-51B6-9CCD-BA2C4D175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03292B-60F1-5809-99D3-8E18F12A74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3BA0B-D3BC-4E4E-8CB5-4EBFE3CD1A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06772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BC4BAF-9A22-B052-C44B-617443798E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2CF389-6625-DE5E-799C-76355AC1BD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113DF0-C999-E1E2-ECE0-4446F4A344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79B847-F384-6636-249D-ADBB52975F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F86DD-C6FE-1140-85C8-99C91FA611DD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304FCB-540C-1CF6-562E-1C7AFD0AB4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981E68-DC97-027C-B633-9761923B2A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3BA0B-D3BC-4E4E-8CB5-4EBFE3CD1A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63874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EAFF-4518-34C8-86D1-FC7CC8CF46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CF65747-2E23-EEE8-C6EC-5717EE5AA34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370B52-4069-4E89-BCE8-9FF6643726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4DA718-F4CE-1AD9-209F-D21EA0542E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F86DD-C6FE-1140-85C8-99C91FA611DD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C83CEE-5A18-4438-6212-A2DC63633E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1EF7ED-4212-006F-BB54-0560256306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93BA0B-D3BC-4E4E-8CB5-4EBFE3CD1A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174930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D763F9C-303C-8CA0-3515-9821C4FF3F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33A3CF-1CBD-2861-BB46-C618F069FE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7A1102-9586-531F-029D-C0F9360C93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5EF86DD-C6FE-1140-85C8-99C91FA611DD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CEA19A-4C66-313C-FBFC-868CD5FBF9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8B62CF-4D82-B2AD-7B9E-8936CF80910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B93BA0B-D3BC-4E4E-8CB5-4EBFE3CD1A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806034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close-up of a black and white photo of dots&#10;&#10;Description automatically generated">
            <a:extLst>
              <a:ext uri="{FF2B5EF4-FFF2-40B4-BE49-F238E27FC236}">
                <a16:creationId xmlns:a16="http://schemas.microsoft.com/office/drawing/2014/main" id="{A520C8CE-9304-78CB-75DA-C93F3C9A76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5457" y="1378458"/>
            <a:ext cx="6282699" cy="294970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D4D2899-8E8A-A4D4-78C0-15C93111DAC1}"/>
              </a:ext>
            </a:extLst>
          </p:cNvPr>
          <p:cNvSpPr txBox="1"/>
          <p:nvPr/>
        </p:nvSpPr>
        <p:spPr>
          <a:xfrm>
            <a:off x="2912461" y="911686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    0h               48h            72h             96h           120h          140h</a:t>
            </a:r>
            <a:endParaRPr lang="en-DE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39E7221-F222-4E4E-6A68-CF2590C52501}"/>
              </a:ext>
            </a:extLst>
          </p:cNvPr>
          <p:cNvSpPr txBox="1"/>
          <p:nvPr/>
        </p:nvSpPr>
        <p:spPr>
          <a:xfrm>
            <a:off x="1620077" y="1749287"/>
            <a:ext cx="1102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dirty="0"/>
              <a:t>FGE2.1 (-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B0ED9E7-C5F6-3E88-BC85-DBCD5BF47231}"/>
              </a:ext>
            </a:extLst>
          </p:cNvPr>
          <p:cNvSpPr txBox="1"/>
          <p:nvPr/>
        </p:nvSpPr>
        <p:spPr>
          <a:xfrm>
            <a:off x="1729406" y="3491947"/>
            <a:ext cx="90281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DE" dirty="0"/>
              <a:t>TM43.4</a:t>
            </a:r>
            <a:br>
              <a:rPr lang="en-DE" dirty="0"/>
            </a:br>
            <a:r>
              <a:rPr lang="en-DE" dirty="0"/>
              <a:t>plan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811B6B3-9A14-645B-29D1-8A5DCBFC4C0E}"/>
              </a:ext>
            </a:extLst>
          </p:cNvPr>
          <p:cNvSpPr txBox="1"/>
          <p:nvPr/>
        </p:nvSpPr>
        <p:spPr>
          <a:xfrm>
            <a:off x="1729406" y="2533673"/>
            <a:ext cx="90281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DE" dirty="0"/>
              <a:t>TM44.2</a:t>
            </a:r>
            <a:br>
              <a:rPr lang="en-DE" dirty="0"/>
            </a:br>
            <a:r>
              <a:rPr lang="en-DE" dirty="0"/>
              <a:t>viral</a:t>
            </a:r>
          </a:p>
        </p:txBody>
      </p:sp>
      <p:sp>
        <p:nvSpPr>
          <p:cNvPr id="13" name="Text Box 1">
            <a:extLst>
              <a:ext uri="{FF2B5EF4-FFF2-40B4-BE49-F238E27FC236}">
                <a16:creationId xmlns:a16="http://schemas.microsoft.com/office/drawing/2014/main" id="{8D0E7AC8-E121-F4B7-99EE-4E405488D229}"/>
              </a:ext>
            </a:extLst>
          </p:cNvPr>
          <p:cNvSpPr txBox="1"/>
          <p:nvPr/>
        </p:nvSpPr>
        <p:spPr>
          <a:xfrm>
            <a:off x="3597477" y="4529834"/>
            <a:ext cx="4638657" cy="1602609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id="http://schemas.microsoft.com/office/word/2016/wordml/cid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ma14="http://schemas.microsoft.com/office/mac/drawingml/2011/main" xmlns:arto="http://schemas.microsoft.com/office/word/2006/arto" xmlns:w16sdtdh="http://schemas.microsoft.com/office/word/2020/wordml/sdtdatahash" xmlns:w16="http://schemas.microsoft.com/office/word/2018/wordml" xmlns:w16cex="http://schemas.microsoft.com/office/word/2018/wordml/cex" xmlns:oel="http://schemas.microsoft.com/office/2019/extlst" xmlns:lc="http://schemas.openxmlformats.org/drawingml/2006/lockedCanvas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DE" sz="1200" b="1" dirty="0">
                <a:latin typeface="Calibri" panose="020F0502020204030204" pitchFamily="34" charset="0"/>
                <a:cs typeface="Calibri" panose="020F0502020204030204" pitchFamily="34" charset="0"/>
              </a:rPr>
              <a:t>Additional File 9: </a:t>
            </a:r>
            <a:r>
              <a:rPr lang="en-AU" sz="1200" b="1" i="1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A. </a:t>
            </a:r>
            <a:r>
              <a:rPr lang="en-AU" sz="1200" b="1" i="1" dirty="0" err="1"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niger</a:t>
            </a:r>
            <a:r>
              <a:rPr lang="en-AU" sz="1200" b="1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secrete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HiBiT</a:t>
            </a:r>
            <a:r>
              <a:rPr lang="en-AU" sz="1200" b="1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tagged collagen III with supernatant stability up to 140 h.</a:t>
            </a:r>
          </a:p>
          <a:p>
            <a:pPr algn="just"/>
            <a:r>
              <a:rPr lang="en-DE" sz="1200" dirty="0"/>
              <a:t>HiBiT Dot-Blot of biological duplicate supernatant samples from TM43.1 and TM44.2. Negative control is the isolate FGE2.1 Supernatant samples collected from 25mL shake flasks of galUA medium with 50 g/L glucose, feeding with NH</a:t>
            </a:r>
            <a:r>
              <a:rPr lang="en-DE" sz="1200" baseline="-25000" dirty="0"/>
              <a:t>4</a:t>
            </a:r>
            <a:r>
              <a:rPr lang="en-DE" sz="1200" baseline="30000" dirty="0"/>
              <a:t>+</a:t>
            </a:r>
            <a:r>
              <a:rPr lang="en-DE" sz="1200" dirty="0"/>
              <a:t> to final concentration of 20</a:t>
            </a:r>
            <a:r>
              <a:rPr lang="de-DE" sz="1200" dirty="0"/>
              <a:t> </a:t>
            </a:r>
            <a:r>
              <a:rPr lang="en-DE" sz="1200" dirty="0"/>
              <a:t>mM every 24 h. Supernatant proteins were pipetted onto nitrocellulose membrane (100µL)</a:t>
            </a:r>
            <a:r>
              <a:rPr lang="de-DE" sz="1200" dirty="0"/>
              <a:t>, and </a:t>
            </a:r>
            <a:r>
              <a:rPr lang="de-DE" sz="1200" dirty="0" err="1"/>
              <a:t>probed</a:t>
            </a:r>
            <a:r>
              <a:rPr lang="de-DE" sz="1200" dirty="0"/>
              <a:t> </a:t>
            </a: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HiBiT</a:t>
            </a:r>
            <a:r>
              <a:rPr lang="de-DE" sz="1200" dirty="0"/>
              <a:t> </a:t>
            </a:r>
            <a:r>
              <a:rPr lang="de-DE" sz="1200" dirty="0" err="1"/>
              <a:t>detection</a:t>
            </a:r>
            <a:r>
              <a:rPr lang="en-DE" sz="1200" dirty="0"/>
              <a:t>.</a:t>
            </a:r>
            <a:endParaRPr lang="en-DE" sz="1200" dirty="0">
              <a:effectLst/>
              <a:latin typeface="Calibri" panose="020F0502020204030204" pitchFamily="34" charset="0"/>
              <a:ea typeface="MS Mincho" panose="02020609040205080304" pitchFamily="49" charset="-128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26184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01</Words>
  <Application>Microsoft Macintosh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U-Pseudonym 1517372033116741</dc:creator>
  <cp:lastModifiedBy>TU-Pseudonym 1517372033116741</cp:lastModifiedBy>
  <cp:revision>2</cp:revision>
  <dcterms:created xsi:type="dcterms:W3CDTF">2025-07-15T18:54:38Z</dcterms:created>
  <dcterms:modified xsi:type="dcterms:W3CDTF">2025-07-15T19:00:47Z</dcterms:modified>
</cp:coreProperties>
</file>